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38417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95471B-EFB4-4A2F-81EF-9C1C84F3AC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8800" y="895320"/>
            <a:ext cx="699480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8800" y="2219760"/>
            <a:ext cx="699480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F70316-02EB-4633-9E3B-915C308AFB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8800" y="89532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72960" y="89532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8800" y="221976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72960" y="221976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E9F64-BE60-406D-98A4-A5B4FB74CD9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8800" y="895320"/>
            <a:ext cx="2252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54000" y="895320"/>
            <a:ext cx="2252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19200" y="895320"/>
            <a:ext cx="2252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8800" y="2219760"/>
            <a:ext cx="2252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54000" y="2219760"/>
            <a:ext cx="2252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19200" y="2219760"/>
            <a:ext cx="2252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74FB8-5225-42ED-9C0B-1EEC846AA5B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8800" y="895320"/>
            <a:ext cx="6994800" cy="253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575"/>
              </a:spcBef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5C501-C809-42C2-A51C-4B968205E1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8800" y="895320"/>
            <a:ext cx="6994800" cy="25351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DC80F-6C24-4184-9C83-8348D14DF4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8800" y="895320"/>
            <a:ext cx="3413160" cy="25351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72960" y="895320"/>
            <a:ext cx="3413160" cy="25351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FAE73F-D633-42A3-BBF5-243774C4B6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D612E5-4EDA-4CAC-BCB9-E7295B729E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8800" y="153720"/>
            <a:ext cx="6994800" cy="2966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575"/>
              </a:spcBef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6221A-D317-4CFC-AAE4-C35C99B82A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800" y="89532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2960" y="895320"/>
            <a:ext cx="3413160" cy="25351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8800" y="221976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22866-22F9-434E-B03F-C99DB465D0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800" y="895320"/>
            <a:ext cx="3413160" cy="25351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2960" y="89532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72960" y="221976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C1F20-074E-49A2-B258-71889EA78C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800" y="89532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72960" y="895320"/>
            <a:ext cx="341316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8800" y="2219760"/>
            <a:ext cx="6994800" cy="120924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/>
          </a:bodyPr>
          <a:p>
            <a:pPr indent="0">
              <a:spcBef>
                <a:spcPts val="575"/>
              </a:spcBef>
              <a:buNone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605B3-75B9-4AC9-981F-934A1C439D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8800" y="153720"/>
            <a:ext cx="6994800" cy="6397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ctr">
            <a:noAutofit/>
          </a:bodyPr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8800" y="895320"/>
            <a:ext cx="6994800" cy="253512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rmAutofit fontScale="85000"/>
          </a:bodyPr>
          <a:p>
            <a:pPr marL="211680" indent="-211680">
              <a:spcBef>
                <a:spcPts val="575"/>
              </a:spcBef>
              <a:buClr>
                <a:srgbClr val="000000"/>
              </a:buClr>
              <a:buFont typeface="Arial"/>
              <a:buChar char="•"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  <a:p>
            <a:pPr lvl="1" marL="458640" indent="-176400">
              <a:spcBef>
                <a:spcPts val="575"/>
              </a:spcBef>
              <a:buClr>
                <a:srgbClr val="000000"/>
              </a:buClr>
              <a:buFont typeface="Arial"/>
              <a:buChar char="–"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  <a:p>
            <a:pPr lvl="2" marL="704160" indent="-140400">
              <a:spcBef>
                <a:spcPts val="575"/>
              </a:spcBef>
              <a:buClr>
                <a:srgbClr val="000000"/>
              </a:buClr>
              <a:buFont typeface="Arial"/>
              <a:buChar char="•"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  <a:p>
            <a:pPr lvl="3" marL="986400" indent="-140400">
              <a:spcBef>
                <a:spcPts val="575"/>
              </a:spcBef>
              <a:buClr>
                <a:srgbClr val="000000"/>
              </a:buClr>
              <a:buFont typeface="Arial"/>
              <a:buChar char="–"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  <a:p>
            <a:pPr lvl="4" marL="1268280" indent="-140040">
              <a:spcBef>
                <a:spcPts val="575"/>
              </a:spcBef>
              <a:buClr>
                <a:srgbClr val="000000"/>
              </a:buClr>
              <a:buFont typeface="Arial"/>
              <a:buChar char="»"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  <a:p>
            <a:pPr lvl="5" marL="1268280" indent="-140040">
              <a:spcBef>
                <a:spcPts val="575"/>
              </a:spcBef>
              <a:buClr>
                <a:srgbClr val="000000"/>
              </a:buClr>
              <a:buFont typeface="Arial"/>
              <a:buChar char="»"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  <a:p>
            <a:pPr lvl="6" marL="1268280" indent="-140040">
              <a:spcBef>
                <a:spcPts val="575"/>
              </a:spcBef>
              <a:buClr>
                <a:srgbClr val="000000"/>
              </a:buClr>
              <a:buFont typeface="Arial"/>
              <a:buChar char="»"/>
              <a:tabLst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8800" y="3497400"/>
            <a:ext cx="1812960" cy="26640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Autofit/>
          </a:bodyPr>
          <a:lstStyle>
            <a:lvl1pPr indent="0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3497400"/>
            <a:ext cx="2460960" cy="26640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Autofit/>
          </a:bodyPr>
          <a:lstStyle>
            <a:lvl1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3497400"/>
            <a:ext cx="1812960" cy="266400"/>
          </a:xfrm>
          <a:prstGeom prst="rect">
            <a:avLst/>
          </a:prstGeom>
          <a:noFill/>
          <a:ln w="0">
            <a:noFill/>
          </a:ln>
        </p:spPr>
        <p:txBody>
          <a:bodyPr lIns="66240" rIns="66240" tIns="33120" bIns="33120" anchor="t">
            <a:noAutofit/>
          </a:bodyPr>
          <a:lstStyle>
            <a:lvl1pPr indent="0" algn="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  <a:defRPr b="0" lang="en-US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663480"/>
                <a:tab algn="l" pos="1327320"/>
                <a:tab algn="l" pos="1990800"/>
                <a:tab algn="l" pos="2654280"/>
                <a:tab algn="l" pos="3317760"/>
                <a:tab algn="l" pos="3981600"/>
                <a:tab algn="l" pos="4645080"/>
                <a:tab algn="l" pos="5308560"/>
                <a:tab algn="l" pos="5972040"/>
                <a:tab algn="l" pos="6635880"/>
                <a:tab algn="l" pos="7299360"/>
                <a:tab algn="l" pos="7962840"/>
                <a:tab algn="l" pos="8626320"/>
                <a:tab algn="l" pos="9290160"/>
                <a:tab algn="l" pos="9953640"/>
                <a:tab algn="l" pos="10617120"/>
              </a:tabLst>
            </a:pPr>
            <a:fld id="{56979178-4D40-4930-8B41-3E300230CCD5}" type="slidenum">
              <a:rPr b="0" lang="en-US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440" y="0"/>
            <a:ext cx="7713000" cy="3840480"/>
            <a:chOff x="1440" y="0"/>
            <a:chExt cx="7713000" cy="3840480"/>
          </a:xfrm>
        </p:grpSpPr>
        <p:grpSp>
          <p:nvGrpSpPr>
            <p:cNvPr id="42" name=""/>
            <p:cNvGrpSpPr/>
            <p:nvPr/>
          </p:nvGrpSpPr>
          <p:grpSpPr>
            <a:xfrm>
              <a:off x="590040" y="3417480"/>
              <a:ext cx="3076200" cy="152640"/>
              <a:chOff x="590040" y="3417480"/>
              <a:chExt cx="3076200" cy="152640"/>
            </a:xfrm>
          </p:grpSpPr>
          <p:sp>
            <p:nvSpPr>
              <p:cNvPr id="43" name=""/>
              <p:cNvSpPr/>
              <p:nvPr/>
            </p:nvSpPr>
            <p:spPr>
              <a:xfrm>
                <a:off x="3385080" y="34174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8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>
                <a:off x="2677320" y="34174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6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1956240" y="34174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1231920" y="34174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590040" y="341748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"/>
            <p:cNvGrpSpPr/>
            <p:nvPr/>
          </p:nvGrpSpPr>
          <p:grpSpPr>
            <a:xfrm>
              <a:off x="607320" y="3359520"/>
              <a:ext cx="2863800" cy="25560"/>
              <a:chOff x="607320" y="3359520"/>
              <a:chExt cx="2863800" cy="25560"/>
            </a:xfrm>
          </p:grpSpPr>
          <p:sp>
            <p:nvSpPr>
              <p:cNvPr id="49" name=""/>
              <p:cNvSpPr/>
              <p:nvPr/>
            </p:nvSpPr>
            <p:spPr>
              <a:xfrm flipV="1">
                <a:off x="607320" y="335952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V="1">
                <a:off x="963000" y="335988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 flipV="1">
                <a:off x="1319040" y="335952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 flipV="1">
                <a:off x="1683000" y="335988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 flipV="1">
                <a:off x="2038680" y="335952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flipV="1">
                <a:off x="2394720" y="335988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 flipV="1">
                <a:off x="2758680" y="335952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 flipV="1">
                <a:off x="3114720" y="335988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 flipV="1">
                <a:off x="3470400" y="335952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607320" y="3359880"/>
                <a:ext cx="2863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9" name=""/>
            <p:cNvGrpSpPr/>
            <p:nvPr/>
          </p:nvGrpSpPr>
          <p:grpSpPr>
            <a:xfrm>
              <a:off x="258120" y="367920"/>
              <a:ext cx="176040" cy="3048480"/>
              <a:chOff x="258120" y="367920"/>
              <a:chExt cx="176040" cy="3048480"/>
            </a:xfrm>
          </p:grpSpPr>
          <p:sp>
            <p:nvSpPr>
              <p:cNvPr id="60" name=""/>
              <p:cNvSpPr/>
              <p:nvPr/>
            </p:nvSpPr>
            <p:spPr>
              <a:xfrm>
                <a:off x="258120" y="326376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258120" y="284940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258120" y="24400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258120" y="20242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.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258120" y="16138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258120" y="11962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58120" y="78516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258120" y="36792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.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" name=""/>
            <p:cNvGrpSpPr/>
            <p:nvPr/>
          </p:nvGrpSpPr>
          <p:grpSpPr>
            <a:xfrm>
              <a:off x="574560" y="462240"/>
              <a:ext cx="32400" cy="2897280"/>
              <a:chOff x="574560" y="462240"/>
              <a:chExt cx="32400" cy="2897280"/>
            </a:xfrm>
          </p:grpSpPr>
          <p:sp>
            <p:nvSpPr>
              <p:cNvPr id="69" name=""/>
              <p:cNvSpPr/>
              <p:nvPr/>
            </p:nvSpPr>
            <p:spPr>
              <a:xfrm flipH="1">
                <a:off x="574560" y="3358800"/>
                <a:ext cx="316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 flipH="1">
                <a:off x="590400" y="315072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H="1">
                <a:off x="574560" y="2942280"/>
                <a:ext cx="316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H="1">
                <a:off x="590400" y="274068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 flipH="1">
                <a:off x="574560" y="2532240"/>
                <a:ext cx="316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 flipH="1">
                <a:off x="590400" y="232380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 flipH="1">
                <a:off x="574560" y="2115360"/>
                <a:ext cx="316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H="1">
                <a:off x="590400" y="191376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 flipH="1">
                <a:off x="574560" y="1705320"/>
                <a:ext cx="316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 flipH="1">
                <a:off x="590400" y="149724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 flipH="1">
                <a:off x="574560" y="1288800"/>
                <a:ext cx="316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 flipH="1">
                <a:off x="590400" y="108036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 flipH="1">
                <a:off x="574560" y="878400"/>
                <a:ext cx="316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 flipH="1">
                <a:off x="590400" y="670320"/>
                <a:ext cx="1584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 flipH="1">
                <a:off x="574560" y="462240"/>
                <a:ext cx="316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 flipV="1">
                <a:off x="606240" y="462240"/>
                <a:ext cx="720" cy="2896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5" name=""/>
            <p:cNvGrpSpPr/>
            <p:nvPr/>
          </p:nvGrpSpPr>
          <p:grpSpPr>
            <a:xfrm>
              <a:off x="730440" y="2122920"/>
              <a:ext cx="40680" cy="32040"/>
              <a:chOff x="730440" y="2122920"/>
              <a:chExt cx="40680" cy="32040"/>
            </a:xfrm>
          </p:grpSpPr>
          <p:sp>
            <p:nvSpPr>
              <p:cNvPr id="86" name=""/>
              <p:cNvSpPr/>
              <p:nvPr/>
            </p:nvSpPr>
            <p:spPr>
              <a:xfrm>
                <a:off x="730440" y="212292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746640" y="21355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8" name=""/>
            <p:cNvGrpSpPr/>
            <p:nvPr/>
          </p:nvGrpSpPr>
          <p:grpSpPr>
            <a:xfrm>
              <a:off x="789840" y="1524600"/>
              <a:ext cx="40680" cy="31680"/>
              <a:chOff x="789840" y="1524600"/>
              <a:chExt cx="40680" cy="31680"/>
            </a:xfrm>
          </p:grpSpPr>
          <p:sp>
            <p:nvSpPr>
              <p:cNvPr id="89" name=""/>
              <p:cNvSpPr/>
              <p:nvPr/>
            </p:nvSpPr>
            <p:spPr>
              <a:xfrm>
                <a:off x="789840" y="152460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806040" y="15372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1" name=""/>
            <p:cNvGrpSpPr/>
            <p:nvPr/>
          </p:nvGrpSpPr>
          <p:grpSpPr>
            <a:xfrm>
              <a:off x="797760" y="1465560"/>
              <a:ext cx="40680" cy="31680"/>
              <a:chOff x="797760" y="1465560"/>
              <a:chExt cx="40680" cy="31680"/>
            </a:xfrm>
          </p:grpSpPr>
          <p:sp>
            <p:nvSpPr>
              <p:cNvPr id="92" name=""/>
              <p:cNvSpPr/>
              <p:nvPr/>
            </p:nvSpPr>
            <p:spPr>
              <a:xfrm>
                <a:off x="797760" y="146556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813960" y="14781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4" name=""/>
            <p:cNvGrpSpPr/>
            <p:nvPr/>
          </p:nvGrpSpPr>
          <p:grpSpPr>
            <a:xfrm>
              <a:off x="806040" y="2252880"/>
              <a:ext cx="40680" cy="33120"/>
              <a:chOff x="806040" y="2252880"/>
              <a:chExt cx="40680" cy="33120"/>
            </a:xfrm>
          </p:grpSpPr>
          <p:sp>
            <p:nvSpPr>
              <p:cNvPr id="95" name=""/>
              <p:cNvSpPr/>
              <p:nvPr/>
            </p:nvSpPr>
            <p:spPr>
              <a:xfrm>
                <a:off x="806040" y="2252880"/>
                <a:ext cx="40680" cy="331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822240" y="22662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7" name=""/>
            <p:cNvGrpSpPr/>
            <p:nvPr/>
          </p:nvGrpSpPr>
          <p:grpSpPr>
            <a:xfrm>
              <a:off x="879840" y="1588680"/>
              <a:ext cx="41040" cy="33120"/>
              <a:chOff x="879840" y="1588680"/>
              <a:chExt cx="41040" cy="33120"/>
            </a:xfrm>
          </p:grpSpPr>
          <p:sp>
            <p:nvSpPr>
              <p:cNvPr id="98" name=""/>
              <p:cNvSpPr/>
              <p:nvPr/>
            </p:nvSpPr>
            <p:spPr>
              <a:xfrm>
                <a:off x="879840" y="1588680"/>
                <a:ext cx="41040" cy="331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896400" y="16016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0" name=""/>
            <p:cNvGrpSpPr/>
            <p:nvPr/>
          </p:nvGrpSpPr>
          <p:grpSpPr>
            <a:xfrm>
              <a:off x="921240" y="2082960"/>
              <a:ext cx="40680" cy="33480"/>
              <a:chOff x="921240" y="2082960"/>
              <a:chExt cx="40680" cy="33480"/>
            </a:xfrm>
          </p:grpSpPr>
          <p:sp>
            <p:nvSpPr>
              <p:cNvPr id="101" name=""/>
              <p:cNvSpPr/>
              <p:nvPr/>
            </p:nvSpPr>
            <p:spPr>
              <a:xfrm>
                <a:off x="921240" y="2082960"/>
                <a:ext cx="4068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937440" y="20962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3" name=""/>
            <p:cNvGrpSpPr/>
            <p:nvPr/>
          </p:nvGrpSpPr>
          <p:grpSpPr>
            <a:xfrm>
              <a:off x="929520" y="2727720"/>
              <a:ext cx="40680" cy="33480"/>
              <a:chOff x="929520" y="2727720"/>
              <a:chExt cx="40680" cy="33480"/>
            </a:xfrm>
          </p:grpSpPr>
          <p:sp>
            <p:nvSpPr>
              <p:cNvPr id="104" name=""/>
              <p:cNvSpPr/>
              <p:nvPr/>
            </p:nvSpPr>
            <p:spPr>
              <a:xfrm>
                <a:off x="929520" y="2727720"/>
                <a:ext cx="4068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945720" y="27410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6" name=""/>
            <p:cNvGrpSpPr/>
            <p:nvPr/>
          </p:nvGrpSpPr>
          <p:grpSpPr>
            <a:xfrm>
              <a:off x="954000" y="1902240"/>
              <a:ext cx="40680" cy="31680"/>
              <a:chOff x="954000" y="1902240"/>
              <a:chExt cx="40680" cy="31680"/>
            </a:xfrm>
          </p:grpSpPr>
          <p:sp>
            <p:nvSpPr>
              <p:cNvPr id="107" name=""/>
              <p:cNvSpPr/>
              <p:nvPr/>
            </p:nvSpPr>
            <p:spPr>
              <a:xfrm>
                <a:off x="954000" y="190224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970200" y="19148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9" name=""/>
            <p:cNvGrpSpPr/>
            <p:nvPr/>
          </p:nvGrpSpPr>
          <p:grpSpPr>
            <a:xfrm>
              <a:off x="954000" y="2122920"/>
              <a:ext cx="40680" cy="32040"/>
              <a:chOff x="954000" y="2122920"/>
              <a:chExt cx="40680" cy="32040"/>
            </a:xfrm>
          </p:grpSpPr>
          <p:sp>
            <p:nvSpPr>
              <p:cNvPr id="110" name=""/>
              <p:cNvSpPr/>
              <p:nvPr/>
            </p:nvSpPr>
            <p:spPr>
              <a:xfrm>
                <a:off x="954000" y="212292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970200" y="21355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2" name=""/>
            <p:cNvGrpSpPr/>
            <p:nvPr/>
          </p:nvGrpSpPr>
          <p:grpSpPr>
            <a:xfrm>
              <a:off x="1111320" y="839880"/>
              <a:ext cx="40680" cy="33120"/>
              <a:chOff x="1111320" y="839880"/>
              <a:chExt cx="40680" cy="33120"/>
            </a:xfrm>
          </p:grpSpPr>
          <p:sp>
            <p:nvSpPr>
              <p:cNvPr id="113" name=""/>
              <p:cNvSpPr/>
              <p:nvPr/>
            </p:nvSpPr>
            <p:spPr>
              <a:xfrm>
                <a:off x="1111320" y="839880"/>
                <a:ext cx="40680" cy="331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1127520" y="8528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5" name=""/>
            <p:cNvGrpSpPr/>
            <p:nvPr/>
          </p:nvGrpSpPr>
          <p:grpSpPr>
            <a:xfrm>
              <a:off x="1111320" y="1751760"/>
              <a:ext cx="40680" cy="31680"/>
              <a:chOff x="1111320" y="1751760"/>
              <a:chExt cx="40680" cy="31680"/>
            </a:xfrm>
          </p:grpSpPr>
          <p:sp>
            <p:nvSpPr>
              <p:cNvPr id="116" name=""/>
              <p:cNvSpPr/>
              <p:nvPr/>
            </p:nvSpPr>
            <p:spPr>
              <a:xfrm>
                <a:off x="1111320" y="175176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1127520" y="176436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8" name=""/>
            <p:cNvGrpSpPr/>
            <p:nvPr/>
          </p:nvGrpSpPr>
          <p:grpSpPr>
            <a:xfrm>
              <a:off x="1111320" y="3118320"/>
              <a:ext cx="40680" cy="33480"/>
              <a:chOff x="1111320" y="3118320"/>
              <a:chExt cx="40680" cy="33480"/>
            </a:xfrm>
          </p:grpSpPr>
          <p:sp>
            <p:nvSpPr>
              <p:cNvPr id="119" name=""/>
              <p:cNvSpPr/>
              <p:nvPr/>
            </p:nvSpPr>
            <p:spPr>
              <a:xfrm>
                <a:off x="1111320" y="3118320"/>
                <a:ext cx="4068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1127520" y="31316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1" name=""/>
            <p:cNvGrpSpPr/>
            <p:nvPr/>
          </p:nvGrpSpPr>
          <p:grpSpPr>
            <a:xfrm>
              <a:off x="1219680" y="1902240"/>
              <a:ext cx="40680" cy="31680"/>
              <a:chOff x="1219680" y="1902240"/>
              <a:chExt cx="40680" cy="31680"/>
            </a:xfrm>
          </p:grpSpPr>
          <p:sp>
            <p:nvSpPr>
              <p:cNvPr id="122" name=""/>
              <p:cNvSpPr/>
              <p:nvPr/>
            </p:nvSpPr>
            <p:spPr>
              <a:xfrm>
                <a:off x="1219680" y="190224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1235880" y="19148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4" name=""/>
            <p:cNvGrpSpPr/>
            <p:nvPr/>
          </p:nvGrpSpPr>
          <p:grpSpPr>
            <a:xfrm>
              <a:off x="1244520" y="1009440"/>
              <a:ext cx="41040" cy="33480"/>
              <a:chOff x="1244520" y="1009440"/>
              <a:chExt cx="41040" cy="33480"/>
            </a:xfrm>
          </p:grpSpPr>
          <p:sp>
            <p:nvSpPr>
              <p:cNvPr id="125" name=""/>
              <p:cNvSpPr/>
              <p:nvPr/>
            </p:nvSpPr>
            <p:spPr>
              <a:xfrm>
                <a:off x="1244520" y="1009440"/>
                <a:ext cx="4104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1260720" y="10227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7" name=""/>
            <p:cNvGrpSpPr/>
            <p:nvPr/>
          </p:nvGrpSpPr>
          <p:grpSpPr>
            <a:xfrm>
              <a:off x="1343160" y="2415600"/>
              <a:ext cx="40680" cy="32040"/>
              <a:chOff x="1343160" y="2415600"/>
              <a:chExt cx="40680" cy="32040"/>
            </a:xfrm>
          </p:grpSpPr>
          <p:sp>
            <p:nvSpPr>
              <p:cNvPr id="128" name=""/>
              <p:cNvSpPr/>
              <p:nvPr/>
            </p:nvSpPr>
            <p:spPr>
              <a:xfrm>
                <a:off x="1343160" y="241560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1359360" y="242856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0" name=""/>
            <p:cNvGrpSpPr/>
            <p:nvPr/>
          </p:nvGrpSpPr>
          <p:grpSpPr>
            <a:xfrm>
              <a:off x="1400400" y="1648080"/>
              <a:ext cx="42480" cy="31680"/>
              <a:chOff x="1400400" y="1648080"/>
              <a:chExt cx="42480" cy="31680"/>
            </a:xfrm>
          </p:grpSpPr>
          <p:sp>
            <p:nvSpPr>
              <p:cNvPr id="131" name=""/>
              <p:cNvSpPr/>
              <p:nvPr/>
            </p:nvSpPr>
            <p:spPr>
              <a:xfrm>
                <a:off x="1400400" y="1648080"/>
                <a:ext cx="424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1417320" y="16606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3" name=""/>
            <p:cNvGrpSpPr/>
            <p:nvPr/>
          </p:nvGrpSpPr>
          <p:grpSpPr>
            <a:xfrm>
              <a:off x="1707840" y="1673280"/>
              <a:ext cx="40680" cy="31680"/>
              <a:chOff x="1707840" y="1673280"/>
              <a:chExt cx="40680" cy="31680"/>
            </a:xfrm>
          </p:grpSpPr>
          <p:sp>
            <p:nvSpPr>
              <p:cNvPr id="134" name=""/>
              <p:cNvSpPr/>
              <p:nvPr/>
            </p:nvSpPr>
            <p:spPr>
              <a:xfrm>
                <a:off x="1707840" y="167328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1724040" y="168588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6" name=""/>
            <p:cNvGrpSpPr/>
            <p:nvPr/>
          </p:nvGrpSpPr>
          <p:grpSpPr>
            <a:xfrm>
              <a:off x="1740600" y="1569600"/>
              <a:ext cx="40680" cy="31680"/>
              <a:chOff x="1740600" y="1569600"/>
              <a:chExt cx="40680" cy="31680"/>
            </a:xfrm>
          </p:grpSpPr>
          <p:sp>
            <p:nvSpPr>
              <p:cNvPr id="137" name=""/>
              <p:cNvSpPr/>
              <p:nvPr/>
            </p:nvSpPr>
            <p:spPr>
              <a:xfrm>
                <a:off x="1740600" y="156960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1756800" y="158220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9" name=""/>
            <p:cNvGrpSpPr/>
            <p:nvPr/>
          </p:nvGrpSpPr>
          <p:grpSpPr>
            <a:xfrm>
              <a:off x="1748520" y="2122920"/>
              <a:ext cx="40680" cy="32040"/>
              <a:chOff x="1748520" y="2122920"/>
              <a:chExt cx="40680" cy="32040"/>
            </a:xfrm>
          </p:grpSpPr>
          <p:sp>
            <p:nvSpPr>
              <p:cNvPr id="140" name=""/>
              <p:cNvSpPr/>
              <p:nvPr/>
            </p:nvSpPr>
            <p:spPr>
              <a:xfrm>
                <a:off x="1748520" y="212292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1764720" y="21355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2" name=""/>
            <p:cNvGrpSpPr/>
            <p:nvPr/>
          </p:nvGrpSpPr>
          <p:grpSpPr>
            <a:xfrm>
              <a:off x="1773360" y="1796760"/>
              <a:ext cx="40680" cy="33120"/>
              <a:chOff x="1773360" y="1796760"/>
              <a:chExt cx="40680" cy="33120"/>
            </a:xfrm>
          </p:grpSpPr>
          <p:sp>
            <p:nvSpPr>
              <p:cNvPr id="143" name=""/>
              <p:cNvSpPr/>
              <p:nvPr/>
            </p:nvSpPr>
            <p:spPr>
              <a:xfrm>
                <a:off x="1773360" y="1796760"/>
                <a:ext cx="40680" cy="331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789560" y="18097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5" name=""/>
            <p:cNvGrpSpPr/>
            <p:nvPr/>
          </p:nvGrpSpPr>
          <p:grpSpPr>
            <a:xfrm>
              <a:off x="1814400" y="2624040"/>
              <a:ext cx="41040" cy="31680"/>
              <a:chOff x="1814400" y="2624040"/>
              <a:chExt cx="41040" cy="31680"/>
            </a:xfrm>
          </p:grpSpPr>
          <p:sp>
            <p:nvSpPr>
              <p:cNvPr id="146" name=""/>
              <p:cNvSpPr/>
              <p:nvPr/>
            </p:nvSpPr>
            <p:spPr>
              <a:xfrm>
                <a:off x="1814400" y="2624040"/>
                <a:ext cx="4104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1830600" y="26366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8" name=""/>
            <p:cNvGrpSpPr/>
            <p:nvPr/>
          </p:nvGrpSpPr>
          <p:grpSpPr>
            <a:xfrm>
              <a:off x="1822680" y="2063880"/>
              <a:ext cx="42120" cy="33480"/>
              <a:chOff x="1822680" y="2063880"/>
              <a:chExt cx="42120" cy="33480"/>
            </a:xfrm>
          </p:grpSpPr>
          <p:sp>
            <p:nvSpPr>
              <p:cNvPr id="149" name=""/>
              <p:cNvSpPr/>
              <p:nvPr/>
            </p:nvSpPr>
            <p:spPr>
              <a:xfrm>
                <a:off x="1822680" y="2063880"/>
                <a:ext cx="4212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1839240" y="207720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1" name=""/>
            <p:cNvGrpSpPr/>
            <p:nvPr/>
          </p:nvGrpSpPr>
          <p:grpSpPr>
            <a:xfrm>
              <a:off x="1996560" y="2396520"/>
              <a:ext cx="40680" cy="32040"/>
              <a:chOff x="1996560" y="2396520"/>
              <a:chExt cx="40680" cy="32040"/>
            </a:xfrm>
          </p:grpSpPr>
          <p:sp>
            <p:nvSpPr>
              <p:cNvPr id="152" name=""/>
              <p:cNvSpPr/>
              <p:nvPr/>
            </p:nvSpPr>
            <p:spPr>
              <a:xfrm>
                <a:off x="1996560" y="239652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2012760" y="24091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4" name=""/>
            <p:cNvGrpSpPr/>
            <p:nvPr/>
          </p:nvGrpSpPr>
          <p:grpSpPr>
            <a:xfrm>
              <a:off x="2013120" y="1692720"/>
              <a:ext cx="40680" cy="33480"/>
              <a:chOff x="2013120" y="1692720"/>
              <a:chExt cx="40680" cy="33480"/>
            </a:xfrm>
          </p:grpSpPr>
          <p:sp>
            <p:nvSpPr>
              <p:cNvPr id="155" name=""/>
              <p:cNvSpPr/>
              <p:nvPr/>
            </p:nvSpPr>
            <p:spPr>
              <a:xfrm>
                <a:off x="2013120" y="1692720"/>
                <a:ext cx="4068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2029320" y="17060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7" name=""/>
            <p:cNvGrpSpPr/>
            <p:nvPr/>
          </p:nvGrpSpPr>
          <p:grpSpPr>
            <a:xfrm>
              <a:off x="2145960" y="2702520"/>
              <a:ext cx="40680" cy="31680"/>
              <a:chOff x="2145960" y="2702520"/>
              <a:chExt cx="40680" cy="31680"/>
            </a:xfrm>
          </p:grpSpPr>
          <p:sp>
            <p:nvSpPr>
              <p:cNvPr id="158" name=""/>
              <p:cNvSpPr/>
              <p:nvPr/>
            </p:nvSpPr>
            <p:spPr>
              <a:xfrm>
                <a:off x="2145960" y="270252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2162160" y="27151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0" name=""/>
            <p:cNvGrpSpPr/>
            <p:nvPr/>
          </p:nvGrpSpPr>
          <p:grpSpPr>
            <a:xfrm>
              <a:off x="2353320" y="1732320"/>
              <a:ext cx="40680" cy="32040"/>
              <a:chOff x="2353320" y="1732320"/>
              <a:chExt cx="40680" cy="32040"/>
            </a:xfrm>
          </p:grpSpPr>
          <p:sp>
            <p:nvSpPr>
              <p:cNvPr id="161" name=""/>
              <p:cNvSpPr/>
              <p:nvPr/>
            </p:nvSpPr>
            <p:spPr>
              <a:xfrm>
                <a:off x="2353320" y="173232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2369520" y="17449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3" name=""/>
            <p:cNvGrpSpPr/>
            <p:nvPr/>
          </p:nvGrpSpPr>
          <p:grpSpPr>
            <a:xfrm>
              <a:off x="2443320" y="1648080"/>
              <a:ext cx="41040" cy="31680"/>
              <a:chOff x="2443320" y="1648080"/>
              <a:chExt cx="41040" cy="31680"/>
            </a:xfrm>
          </p:grpSpPr>
          <p:sp>
            <p:nvSpPr>
              <p:cNvPr id="164" name=""/>
              <p:cNvSpPr/>
              <p:nvPr/>
            </p:nvSpPr>
            <p:spPr>
              <a:xfrm>
                <a:off x="2443320" y="1648080"/>
                <a:ext cx="4104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2459520" y="16606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6" name=""/>
            <p:cNvGrpSpPr/>
            <p:nvPr/>
          </p:nvGrpSpPr>
          <p:grpSpPr>
            <a:xfrm>
              <a:off x="2484720" y="2350440"/>
              <a:ext cx="42120" cy="33120"/>
              <a:chOff x="2484720" y="2350440"/>
              <a:chExt cx="42120" cy="33120"/>
            </a:xfrm>
          </p:grpSpPr>
          <p:sp>
            <p:nvSpPr>
              <p:cNvPr id="167" name=""/>
              <p:cNvSpPr/>
              <p:nvPr/>
            </p:nvSpPr>
            <p:spPr>
              <a:xfrm>
                <a:off x="2484720" y="2350440"/>
                <a:ext cx="42120" cy="331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2501280" y="236376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9" name=""/>
            <p:cNvGrpSpPr/>
            <p:nvPr/>
          </p:nvGrpSpPr>
          <p:grpSpPr>
            <a:xfrm>
              <a:off x="2890080" y="1959840"/>
              <a:ext cx="40680" cy="31680"/>
              <a:chOff x="2890080" y="1959840"/>
              <a:chExt cx="40680" cy="31680"/>
            </a:xfrm>
          </p:grpSpPr>
          <p:sp>
            <p:nvSpPr>
              <p:cNvPr id="170" name=""/>
              <p:cNvSpPr/>
              <p:nvPr/>
            </p:nvSpPr>
            <p:spPr>
              <a:xfrm>
                <a:off x="2890080" y="195984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2906280" y="19724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2" name=""/>
            <p:cNvGrpSpPr/>
            <p:nvPr/>
          </p:nvGrpSpPr>
          <p:grpSpPr>
            <a:xfrm>
              <a:off x="2990520" y="1628640"/>
              <a:ext cx="40680" cy="31680"/>
              <a:chOff x="2990520" y="1628640"/>
              <a:chExt cx="40680" cy="31680"/>
            </a:xfrm>
          </p:grpSpPr>
          <p:sp>
            <p:nvSpPr>
              <p:cNvPr id="173" name=""/>
              <p:cNvSpPr/>
              <p:nvPr/>
            </p:nvSpPr>
            <p:spPr>
              <a:xfrm>
                <a:off x="2990520" y="162864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3006720" y="16412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5" name=""/>
            <p:cNvGrpSpPr/>
            <p:nvPr/>
          </p:nvGrpSpPr>
          <p:grpSpPr>
            <a:xfrm>
              <a:off x="607320" y="1934280"/>
              <a:ext cx="2862360" cy="78120"/>
              <a:chOff x="607320" y="1934280"/>
              <a:chExt cx="2862360" cy="78120"/>
            </a:xfrm>
          </p:grpSpPr>
          <p:sp>
            <p:nvSpPr>
              <p:cNvPr id="176" name=""/>
              <p:cNvSpPr/>
              <p:nvPr/>
            </p:nvSpPr>
            <p:spPr>
              <a:xfrm>
                <a:off x="607320" y="1934280"/>
                <a:ext cx="2862360" cy="78120"/>
              </a:xfrm>
              <a:custGeom>
                <a:avLst/>
                <a:gdLst/>
                <a:ahLst/>
                <a:rect l="l" t="t" r="r" b="b"/>
                <a:pathLst>
                  <a:path w="2768" h="96">
                    <a:moveTo>
                      <a:pt x="0" y="0"/>
                    </a:moveTo>
                    <a:lnTo>
                      <a:pt x="2768" y="96"/>
                    </a:lnTo>
                    <a:lnTo>
                      <a:pt x="2768" y="96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607320" y="1934280"/>
                <a:ext cx="2862360" cy="78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8" name=""/>
            <p:cNvSpPr/>
            <p:nvPr/>
          </p:nvSpPr>
          <p:spPr>
            <a:xfrm>
              <a:off x="1383840" y="33120"/>
              <a:ext cx="1422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63480"/>
                  <a:tab algn="l" pos="1327320"/>
                  <a:tab algn="l" pos="1990800"/>
                  <a:tab algn="l" pos="2654280"/>
                  <a:tab algn="l" pos="3317760"/>
                  <a:tab algn="l" pos="3981600"/>
                  <a:tab algn="l" pos="4645080"/>
                  <a:tab algn="l" pos="5308560"/>
                  <a:tab algn="l" pos="5972040"/>
                  <a:tab algn="l" pos="6635880"/>
                  <a:tab algn="l" pos="7299360"/>
                  <a:tab algn="l" pos="7962840"/>
                  <a:tab algn="l" pos="8626320"/>
                  <a:tab algn="l" pos="9290160"/>
                  <a:tab algn="l" pos="9953640"/>
                  <a:tab algn="l" pos="106171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Palatino"/>
                </a:rPr>
                <a:t>a)  Meal Fat Oxid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550600" y="3687840"/>
              <a:ext cx="2631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63480"/>
                  <a:tab algn="l" pos="1327320"/>
                  <a:tab algn="l" pos="1990800"/>
                  <a:tab algn="l" pos="2654280"/>
                  <a:tab algn="l" pos="3317760"/>
                  <a:tab algn="l" pos="3981600"/>
                  <a:tab algn="l" pos="4645080"/>
                  <a:tab algn="l" pos="5308560"/>
                  <a:tab algn="l" pos="5972040"/>
                  <a:tab algn="l" pos="6635880"/>
                  <a:tab algn="l" pos="7299360"/>
                  <a:tab algn="l" pos="7962840"/>
                  <a:tab algn="l" pos="8626320"/>
                  <a:tab algn="l" pos="9290160"/>
                  <a:tab algn="l" pos="9953640"/>
                  <a:tab algn="l" pos="106171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rea under glucose curve (mmol/L.360 min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rot="16200000">
              <a:off x="-647640" y="1834920"/>
              <a:ext cx="1451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663480"/>
                  <a:tab algn="l" pos="1327320"/>
                  <a:tab algn="l" pos="1990800"/>
                  <a:tab algn="l" pos="2654280"/>
                  <a:tab algn="l" pos="3317760"/>
                  <a:tab algn="l" pos="3981600"/>
                  <a:tab algn="l" pos="4645080"/>
                  <a:tab algn="l" pos="5308560"/>
                  <a:tab algn="l" pos="5972040"/>
                  <a:tab algn="l" pos="6635880"/>
                  <a:tab algn="l" pos="7299360"/>
                  <a:tab algn="l" pos="7962840"/>
                  <a:tab algn="l" pos="8626320"/>
                  <a:tab algn="l" pos="9290160"/>
                  <a:tab algn="l" pos="9953640"/>
                  <a:tab algn="l" pos="106171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eal fat oxidation (g/6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761760" y="433440"/>
              <a:ext cx="2219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63480"/>
                  <a:tab algn="l" pos="1327320"/>
                  <a:tab algn="l" pos="1990800"/>
                  <a:tab algn="l" pos="2654280"/>
                  <a:tab algn="l" pos="3317760"/>
                  <a:tab algn="l" pos="3981600"/>
                  <a:tab algn="l" pos="4645080"/>
                  <a:tab algn="l" pos="5308560"/>
                  <a:tab algn="l" pos="5972040"/>
                  <a:tab algn="l" pos="6635880"/>
                  <a:tab algn="l" pos="7299360"/>
                  <a:tab algn="l" pos="7962840"/>
                  <a:tab algn="l" pos="8626320"/>
                  <a:tab algn="l" pos="9290160"/>
                  <a:tab algn="l" pos="9953640"/>
                  <a:tab algn="l" pos="106171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y = 0.88878 - 4.8099e-6x   R^2 = 0.0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2" name=""/>
            <p:cNvGrpSpPr/>
            <p:nvPr/>
          </p:nvGrpSpPr>
          <p:grpSpPr>
            <a:xfrm>
              <a:off x="4614480" y="3403080"/>
              <a:ext cx="3099960" cy="152640"/>
              <a:chOff x="4614480" y="3403080"/>
              <a:chExt cx="3099960" cy="152640"/>
            </a:xfrm>
          </p:grpSpPr>
          <p:sp>
            <p:nvSpPr>
              <p:cNvPr id="183" name=""/>
              <p:cNvSpPr/>
              <p:nvPr/>
            </p:nvSpPr>
            <p:spPr>
              <a:xfrm>
                <a:off x="7433280" y="34030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8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6717240" y="34030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6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5991120" y="34030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5263200" y="3403080"/>
                <a:ext cx="281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4614480" y="340308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8" name=""/>
            <p:cNvGrpSpPr/>
            <p:nvPr/>
          </p:nvGrpSpPr>
          <p:grpSpPr>
            <a:xfrm>
              <a:off x="4631040" y="3345120"/>
              <a:ext cx="2892240" cy="25560"/>
              <a:chOff x="4631040" y="3345120"/>
              <a:chExt cx="2892240" cy="25560"/>
            </a:xfrm>
          </p:grpSpPr>
          <p:sp>
            <p:nvSpPr>
              <p:cNvPr id="189" name=""/>
              <p:cNvSpPr/>
              <p:nvPr/>
            </p:nvSpPr>
            <p:spPr>
              <a:xfrm flipV="1">
                <a:off x="4631040" y="3345120"/>
                <a:ext cx="108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 flipV="1">
                <a:off x="4990320" y="3345480"/>
                <a:ext cx="72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 flipV="1">
                <a:off x="5349600" y="3345120"/>
                <a:ext cx="72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V="1">
                <a:off x="5717160" y="3345480"/>
                <a:ext cx="108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 flipV="1">
                <a:off x="6076440" y="3345120"/>
                <a:ext cx="108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 flipV="1">
                <a:off x="6435720" y="3345480"/>
                <a:ext cx="108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 flipV="1">
                <a:off x="6803280" y="3345120"/>
                <a:ext cx="108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 flipV="1">
                <a:off x="7162560" y="3345480"/>
                <a:ext cx="1080" cy="129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 flipV="1">
                <a:off x="7522200" y="3345120"/>
                <a:ext cx="1080" cy="25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4631040" y="3345480"/>
                <a:ext cx="289116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9" name=""/>
            <p:cNvGrpSpPr/>
            <p:nvPr/>
          </p:nvGrpSpPr>
          <p:grpSpPr>
            <a:xfrm>
              <a:off x="4354200" y="446040"/>
              <a:ext cx="140760" cy="3028320"/>
              <a:chOff x="4354200" y="446040"/>
              <a:chExt cx="140760" cy="3028320"/>
            </a:xfrm>
          </p:grpSpPr>
          <p:sp>
            <p:nvSpPr>
              <p:cNvPr id="200" name=""/>
              <p:cNvSpPr/>
              <p:nvPr/>
            </p:nvSpPr>
            <p:spPr>
              <a:xfrm>
                <a:off x="4354200" y="332172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4354200" y="274068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4354200" y="216648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4354200" y="158976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4354200" y="102024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4354200" y="446040"/>
                <a:ext cx="140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663480"/>
                    <a:tab algn="l" pos="1327320"/>
                    <a:tab algn="l" pos="1990800"/>
                    <a:tab algn="l" pos="2654280"/>
                    <a:tab algn="l" pos="3317760"/>
                    <a:tab algn="l" pos="3981600"/>
                    <a:tab algn="l" pos="4645080"/>
                    <a:tab algn="l" pos="5308560"/>
                    <a:tab algn="l" pos="5972040"/>
                    <a:tab algn="l" pos="6635880"/>
                    <a:tab algn="l" pos="7299360"/>
                    <a:tab algn="l" pos="7962840"/>
                    <a:tab algn="l" pos="8626320"/>
                    <a:tab algn="l" pos="9290160"/>
                    <a:tab algn="l" pos="9953640"/>
                    <a:tab algn="l" pos="1061712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6" name=""/>
            <p:cNvGrpSpPr/>
            <p:nvPr/>
          </p:nvGrpSpPr>
          <p:grpSpPr>
            <a:xfrm>
              <a:off x="4596840" y="469800"/>
              <a:ext cx="34200" cy="2877120"/>
              <a:chOff x="4596840" y="469800"/>
              <a:chExt cx="34200" cy="2877120"/>
            </a:xfrm>
          </p:grpSpPr>
          <p:sp>
            <p:nvSpPr>
              <p:cNvPr id="207" name=""/>
              <p:cNvSpPr/>
              <p:nvPr/>
            </p:nvSpPr>
            <p:spPr>
              <a:xfrm flipH="1">
                <a:off x="4596840" y="3346200"/>
                <a:ext cx="33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 flipH="1">
                <a:off x="4613040" y="3061800"/>
                <a:ext cx="1620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 flipH="1">
                <a:off x="4596840" y="2770920"/>
                <a:ext cx="33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 flipH="1">
                <a:off x="4613040" y="2480040"/>
                <a:ext cx="1620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 flipH="1">
                <a:off x="4596840" y="2195640"/>
                <a:ext cx="33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 flipH="1">
                <a:off x="4613040" y="1911240"/>
                <a:ext cx="1620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 flipH="1">
                <a:off x="4596840" y="1620360"/>
                <a:ext cx="33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 flipH="1">
                <a:off x="4613040" y="1329480"/>
                <a:ext cx="1620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 flipH="1">
                <a:off x="4596840" y="1045080"/>
                <a:ext cx="33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H="1">
                <a:off x="4613040" y="761040"/>
                <a:ext cx="1620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 flipH="1">
                <a:off x="4596840" y="470160"/>
                <a:ext cx="331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 flipV="1">
                <a:off x="4629960" y="469800"/>
                <a:ext cx="1080" cy="2876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9" name=""/>
            <p:cNvGrpSpPr/>
            <p:nvPr/>
          </p:nvGrpSpPr>
          <p:grpSpPr>
            <a:xfrm>
              <a:off x="4755600" y="1782000"/>
              <a:ext cx="41040" cy="31680"/>
              <a:chOff x="4755600" y="1782000"/>
              <a:chExt cx="41040" cy="31680"/>
            </a:xfrm>
          </p:grpSpPr>
          <p:sp>
            <p:nvSpPr>
              <p:cNvPr id="220" name=""/>
              <p:cNvSpPr/>
              <p:nvPr/>
            </p:nvSpPr>
            <p:spPr>
              <a:xfrm>
                <a:off x="4755600" y="1782000"/>
                <a:ext cx="4104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4771800" y="17946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2" name=""/>
            <p:cNvGrpSpPr/>
            <p:nvPr/>
          </p:nvGrpSpPr>
          <p:grpSpPr>
            <a:xfrm>
              <a:off x="4815000" y="2014200"/>
              <a:ext cx="40680" cy="32040"/>
              <a:chOff x="4815000" y="2014200"/>
              <a:chExt cx="40680" cy="32040"/>
            </a:xfrm>
          </p:grpSpPr>
          <p:sp>
            <p:nvSpPr>
              <p:cNvPr id="223" name=""/>
              <p:cNvSpPr/>
              <p:nvPr/>
            </p:nvSpPr>
            <p:spPr>
              <a:xfrm>
                <a:off x="4815000" y="201420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4831200" y="20268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5" name=""/>
            <p:cNvGrpSpPr/>
            <p:nvPr/>
          </p:nvGrpSpPr>
          <p:grpSpPr>
            <a:xfrm>
              <a:off x="4823280" y="2150280"/>
              <a:ext cx="40680" cy="32040"/>
              <a:chOff x="4823280" y="2150280"/>
              <a:chExt cx="40680" cy="32040"/>
            </a:xfrm>
          </p:grpSpPr>
          <p:sp>
            <p:nvSpPr>
              <p:cNvPr id="226" name=""/>
              <p:cNvSpPr/>
              <p:nvPr/>
            </p:nvSpPr>
            <p:spPr>
              <a:xfrm>
                <a:off x="4823280" y="215028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4839480" y="21628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8" name=""/>
            <p:cNvGrpSpPr/>
            <p:nvPr/>
          </p:nvGrpSpPr>
          <p:grpSpPr>
            <a:xfrm>
              <a:off x="4831200" y="2375640"/>
              <a:ext cx="40680" cy="33480"/>
              <a:chOff x="4831200" y="2375640"/>
              <a:chExt cx="40680" cy="33480"/>
            </a:xfrm>
          </p:grpSpPr>
          <p:sp>
            <p:nvSpPr>
              <p:cNvPr id="229" name=""/>
              <p:cNvSpPr/>
              <p:nvPr/>
            </p:nvSpPr>
            <p:spPr>
              <a:xfrm>
                <a:off x="4831200" y="2375640"/>
                <a:ext cx="4068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4847400" y="238896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1" name=""/>
            <p:cNvGrpSpPr/>
            <p:nvPr/>
          </p:nvGrpSpPr>
          <p:grpSpPr>
            <a:xfrm>
              <a:off x="4906800" y="2105640"/>
              <a:ext cx="40680" cy="31680"/>
              <a:chOff x="4906800" y="2105640"/>
              <a:chExt cx="40680" cy="31680"/>
            </a:xfrm>
          </p:grpSpPr>
          <p:sp>
            <p:nvSpPr>
              <p:cNvPr id="232" name=""/>
              <p:cNvSpPr/>
              <p:nvPr/>
            </p:nvSpPr>
            <p:spPr>
              <a:xfrm>
                <a:off x="4906800" y="210564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4923000" y="21182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4" name=""/>
            <p:cNvGrpSpPr/>
            <p:nvPr/>
          </p:nvGrpSpPr>
          <p:grpSpPr>
            <a:xfrm>
              <a:off x="4947840" y="2990160"/>
              <a:ext cx="40680" cy="32040"/>
              <a:chOff x="4947840" y="2990160"/>
              <a:chExt cx="40680" cy="32040"/>
            </a:xfrm>
          </p:grpSpPr>
          <p:sp>
            <p:nvSpPr>
              <p:cNvPr id="235" name=""/>
              <p:cNvSpPr/>
              <p:nvPr/>
            </p:nvSpPr>
            <p:spPr>
              <a:xfrm>
                <a:off x="4947840" y="299016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4964040" y="300276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7" name=""/>
            <p:cNvGrpSpPr/>
            <p:nvPr/>
          </p:nvGrpSpPr>
          <p:grpSpPr>
            <a:xfrm>
              <a:off x="4956120" y="2111760"/>
              <a:ext cx="42480" cy="32040"/>
              <a:chOff x="4956120" y="2111760"/>
              <a:chExt cx="42480" cy="32040"/>
            </a:xfrm>
          </p:grpSpPr>
          <p:sp>
            <p:nvSpPr>
              <p:cNvPr id="238" name=""/>
              <p:cNvSpPr/>
              <p:nvPr/>
            </p:nvSpPr>
            <p:spPr>
              <a:xfrm>
                <a:off x="4956120" y="2111760"/>
                <a:ext cx="424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4973040" y="21247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0" name=""/>
            <p:cNvGrpSpPr/>
            <p:nvPr/>
          </p:nvGrpSpPr>
          <p:grpSpPr>
            <a:xfrm>
              <a:off x="4980600" y="2905560"/>
              <a:ext cx="42480" cy="33120"/>
              <a:chOff x="4980600" y="2905560"/>
              <a:chExt cx="42480" cy="33120"/>
            </a:xfrm>
          </p:grpSpPr>
          <p:sp>
            <p:nvSpPr>
              <p:cNvPr id="241" name=""/>
              <p:cNvSpPr/>
              <p:nvPr/>
            </p:nvSpPr>
            <p:spPr>
              <a:xfrm>
                <a:off x="4980600" y="2905560"/>
                <a:ext cx="42480" cy="331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4997520" y="291888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3" name=""/>
            <p:cNvGrpSpPr/>
            <p:nvPr/>
          </p:nvGrpSpPr>
          <p:grpSpPr>
            <a:xfrm>
              <a:off x="4980600" y="1859040"/>
              <a:ext cx="42480" cy="31680"/>
              <a:chOff x="4980600" y="1859040"/>
              <a:chExt cx="42480" cy="31680"/>
            </a:xfrm>
          </p:grpSpPr>
          <p:sp>
            <p:nvSpPr>
              <p:cNvPr id="244" name=""/>
              <p:cNvSpPr/>
              <p:nvPr/>
            </p:nvSpPr>
            <p:spPr>
              <a:xfrm>
                <a:off x="4980600" y="1859040"/>
                <a:ext cx="424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"/>
              <p:cNvSpPr/>
              <p:nvPr/>
            </p:nvSpPr>
            <p:spPr>
              <a:xfrm>
                <a:off x="4997520" y="18716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6" name=""/>
            <p:cNvGrpSpPr/>
            <p:nvPr/>
          </p:nvGrpSpPr>
          <p:grpSpPr>
            <a:xfrm>
              <a:off x="5140080" y="1458720"/>
              <a:ext cx="42480" cy="32040"/>
              <a:chOff x="5140080" y="1458720"/>
              <a:chExt cx="42480" cy="32040"/>
            </a:xfrm>
          </p:grpSpPr>
          <p:sp>
            <p:nvSpPr>
              <p:cNvPr id="247" name=""/>
              <p:cNvSpPr/>
              <p:nvPr/>
            </p:nvSpPr>
            <p:spPr>
              <a:xfrm>
                <a:off x="5140080" y="1458720"/>
                <a:ext cx="424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5157000" y="147132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9" name=""/>
            <p:cNvGrpSpPr/>
            <p:nvPr/>
          </p:nvGrpSpPr>
          <p:grpSpPr>
            <a:xfrm>
              <a:off x="5248440" y="2952000"/>
              <a:ext cx="42480" cy="31680"/>
              <a:chOff x="5248440" y="2952000"/>
              <a:chExt cx="42480" cy="31680"/>
            </a:xfrm>
          </p:grpSpPr>
          <p:sp>
            <p:nvSpPr>
              <p:cNvPr id="250" name=""/>
              <p:cNvSpPr/>
              <p:nvPr/>
            </p:nvSpPr>
            <p:spPr>
              <a:xfrm>
                <a:off x="5248440" y="2952000"/>
                <a:ext cx="424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5265360" y="296460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2" name=""/>
            <p:cNvGrpSpPr/>
            <p:nvPr/>
          </p:nvGrpSpPr>
          <p:grpSpPr>
            <a:xfrm>
              <a:off x="5432400" y="1387080"/>
              <a:ext cx="42480" cy="33120"/>
              <a:chOff x="5432400" y="1387080"/>
              <a:chExt cx="42480" cy="33120"/>
            </a:xfrm>
          </p:grpSpPr>
          <p:sp>
            <p:nvSpPr>
              <p:cNvPr id="253" name=""/>
              <p:cNvSpPr/>
              <p:nvPr/>
            </p:nvSpPr>
            <p:spPr>
              <a:xfrm>
                <a:off x="5432400" y="1387080"/>
                <a:ext cx="42480" cy="3312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5449320" y="14000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5" name=""/>
            <p:cNvGrpSpPr/>
            <p:nvPr/>
          </p:nvGrpSpPr>
          <p:grpSpPr>
            <a:xfrm>
              <a:off x="5741280" y="1756800"/>
              <a:ext cx="42480" cy="31680"/>
              <a:chOff x="5741280" y="1756800"/>
              <a:chExt cx="42480" cy="31680"/>
            </a:xfrm>
          </p:grpSpPr>
          <p:sp>
            <p:nvSpPr>
              <p:cNvPr id="256" name=""/>
              <p:cNvSpPr/>
              <p:nvPr/>
            </p:nvSpPr>
            <p:spPr>
              <a:xfrm>
                <a:off x="5741280" y="1756800"/>
                <a:ext cx="424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5758200" y="17694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58" name=""/>
            <p:cNvGrpSpPr/>
            <p:nvPr/>
          </p:nvGrpSpPr>
          <p:grpSpPr>
            <a:xfrm>
              <a:off x="5775840" y="1348560"/>
              <a:ext cx="40680" cy="31680"/>
              <a:chOff x="5775840" y="1348560"/>
              <a:chExt cx="40680" cy="31680"/>
            </a:xfrm>
          </p:grpSpPr>
          <p:sp>
            <p:nvSpPr>
              <p:cNvPr id="259" name=""/>
              <p:cNvSpPr/>
              <p:nvPr/>
            </p:nvSpPr>
            <p:spPr>
              <a:xfrm>
                <a:off x="5775840" y="134856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5792040" y="13611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1" name=""/>
            <p:cNvGrpSpPr/>
            <p:nvPr/>
          </p:nvGrpSpPr>
          <p:grpSpPr>
            <a:xfrm>
              <a:off x="5808600" y="1569600"/>
              <a:ext cx="42480" cy="31680"/>
              <a:chOff x="5808600" y="1569600"/>
              <a:chExt cx="42480" cy="31680"/>
            </a:xfrm>
          </p:grpSpPr>
          <p:sp>
            <p:nvSpPr>
              <p:cNvPr id="262" name=""/>
              <p:cNvSpPr/>
              <p:nvPr/>
            </p:nvSpPr>
            <p:spPr>
              <a:xfrm>
                <a:off x="5808600" y="1569600"/>
                <a:ext cx="424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5825520" y="15822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4" name=""/>
            <p:cNvGrpSpPr/>
            <p:nvPr/>
          </p:nvGrpSpPr>
          <p:grpSpPr>
            <a:xfrm>
              <a:off x="5851440" y="2518560"/>
              <a:ext cx="40680" cy="31680"/>
              <a:chOff x="5851440" y="2518560"/>
              <a:chExt cx="40680" cy="31680"/>
            </a:xfrm>
          </p:grpSpPr>
          <p:sp>
            <p:nvSpPr>
              <p:cNvPr id="265" name=""/>
              <p:cNvSpPr/>
              <p:nvPr/>
            </p:nvSpPr>
            <p:spPr>
              <a:xfrm>
                <a:off x="5851440" y="2518560"/>
                <a:ext cx="406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5867640" y="253116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67" name=""/>
            <p:cNvGrpSpPr/>
            <p:nvPr/>
          </p:nvGrpSpPr>
          <p:grpSpPr>
            <a:xfrm>
              <a:off x="5859720" y="1865160"/>
              <a:ext cx="40680" cy="33480"/>
              <a:chOff x="5859720" y="1865160"/>
              <a:chExt cx="40680" cy="33480"/>
            </a:xfrm>
          </p:grpSpPr>
          <p:sp>
            <p:nvSpPr>
              <p:cNvPr id="268" name=""/>
              <p:cNvSpPr/>
              <p:nvPr/>
            </p:nvSpPr>
            <p:spPr>
              <a:xfrm>
                <a:off x="5859720" y="1865160"/>
                <a:ext cx="4068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5875920" y="187848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0" name=""/>
            <p:cNvGrpSpPr/>
            <p:nvPr/>
          </p:nvGrpSpPr>
          <p:grpSpPr>
            <a:xfrm>
              <a:off x="6033600" y="2020680"/>
              <a:ext cx="42480" cy="31680"/>
              <a:chOff x="6033600" y="2020680"/>
              <a:chExt cx="42480" cy="31680"/>
            </a:xfrm>
          </p:grpSpPr>
          <p:sp>
            <p:nvSpPr>
              <p:cNvPr id="271" name=""/>
              <p:cNvSpPr/>
              <p:nvPr/>
            </p:nvSpPr>
            <p:spPr>
              <a:xfrm>
                <a:off x="6033600" y="2020680"/>
                <a:ext cx="4248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6050520" y="203328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3" name=""/>
            <p:cNvGrpSpPr/>
            <p:nvPr/>
          </p:nvGrpSpPr>
          <p:grpSpPr>
            <a:xfrm>
              <a:off x="6051600" y="2014200"/>
              <a:ext cx="40680" cy="32040"/>
              <a:chOff x="6051600" y="2014200"/>
              <a:chExt cx="40680" cy="32040"/>
            </a:xfrm>
          </p:grpSpPr>
          <p:sp>
            <p:nvSpPr>
              <p:cNvPr id="274" name=""/>
              <p:cNvSpPr/>
              <p:nvPr/>
            </p:nvSpPr>
            <p:spPr>
              <a:xfrm>
                <a:off x="6051600" y="201420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6067800" y="202680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6" name=""/>
            <p:cNvGrpSpPr/>
            <p:nvPr/>
          </p:nvGrpSpPr>
          <p:grpSpPr>
            <a:xfrm>
              <a:off x="6184800" y="2318040"/>
              <a:ext cx="40680" cy="32040"/>
              <a:chOff x="6184800" y="2318040"/>
              <a:chExt cx="40680" cy="32040"/>
            </a:xfrm>
          </p:grpSpPr>
          <p:sp>
            <p:nvSpPr>
              <p:cNvPr id="277" name=""/>
              <p:cNvSpPr/>
              <p:nvPr/>
            </p:nvSpPr>
            <p:spPr>
              <a:xfrm>
                <a:off x="6184800" y="2318040"/>
                <a:ext cx="40680" cy="3204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6201000" y="23306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79" name=""/>
            <p:cNvGrpSpPr/>
            <p:nvPr/>
          </p:nvGrpSpPr>
          <p:grpSpPr>
            <a:xfrm>
              <a:off x="6393240" y="1614240"/>
              <a:ext cx="42120" cy="31680"/>
              <a:chOff x="6393240" y="1614240"/>
              <a:chExt cx="42120" cy="31680"/>
            </a:xfrm>
          </p:grpSpPr>
          <p:sp>
            <p:nvSpPr>
              <p:cNvPr id="280" name=""/>
              <p:cNvSpPr/>
              <p:nvPr/>
            </p:nvSpPr>
            <p:spPr>
              <a:xfrm>
                <a:off x="6393240" y="1614240"/>
                <a:ext cx="4212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6409800" y="162684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2" name=""/>
            <p:cNvGrpSpPr/>
            <p:nvPr/>
          </p:nvGrpSpPr>
          <p:grpSpPr>
            <a:xfrm>
              <a:off x="6485400" y="1361160"/>
              <a:ext cx="42120" cy="33480"/>
              <a:chOff x="6485400" y="1361160"/>
              <a:chExt cx="42120" cy="33480"/>
            </a:xfrm>
          </p:grpSpPr>
          <p:sp>
            <p:nvSpPr>
              <p:cNvPr id="283" name=""/>
              <p:cNvSpPr/>
              <p:nvPr/>
            </p:nvSpPr>
            <p:spPr>
              <a:xfrm>
                <a:off x="6485400" y="1361160"/>
                <a:ext cx="4212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6501960" y="137448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5" name=""/>
            <p:cNvGrpSpPr/>
            <p:nvPr/>
          </p:nvGrpSpPr>
          <p:grpSpPr>
            <a:xfrm>
              <a:off x="6527880" y="1427040"/>
              <a:ext cx="41040" cy="31680"/>
              <a:chOff x="6527880" y="1427040"/>
              <a:chExt cx="41040" cy="31680"/>
            </a:xfrm>
          </p:grpSpPr>
          <p:sp>
            <p:nvSpPr>
              <p:cNvPr id="286" name=""/>
              <p:cNvSpPr/>
              <p:nvPr/>
            </p:nvSpPr>
            <p:spPr>
              <a:xfrm>
                <a:off x="6527880" y="1427040"/>
                <a:ext cx="4104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>
                <a:off x="6544080" y="143964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88" name=""/>
            <p:cNvGrpSpPr/>
            <p:nvPr/>
          </p:nvGrpSpPr>
          <p:grpSpPr>
            <a:xfrm>
              <a:off x="6936480" y="1891080"/>
              <a:ext cx="41040" cy="33480"/>
              <a:chOff x="6936480" y="1891080"/>
              <a:chExt cx="41040" cy="33480"/>
            </a:xfrm>
          </p:grpSpPr>
          <p:sp>
            <p:nvSpPr>
              <p:cNvPr id="289" name=""/>
              <p:cNvSpPr/>
              <p:nvPr/>
            </p:nvSpPr>
            <p:spPr>
              <a:xfrm>
                <a:off x="6936480" y="1891080"/>
                <a:ext cx="41040" cy="334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>
                <a:off x="6952680" y="1904400"/>
                <a:ext cx="108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1" name=""/>
            <p:cNvGrpSpPr/>
            <p:nvPr/>
          </p:nvGrpSpPr>
          <p:grpSpPr>
            <a:xfrm>
              <a:off x="7036920" y="657360"/>
              <a:ext cx="41040" cy="31680"/>
              <a:chOff x="7036920" y="657360"/>
              <a:chExt cx="41040" cy="31680"/>
            </a:xfrm>
          </p:grpSpPr>
          <p:sp>
            <p:nvSpPr>
              <p:cNvPr id="292" name=""/>
              <p:cNvSpPr/>
              <p:nvPr/>
            </p:nvSpPr>
            <p:spPr>
              <a:xfrm>
                <a:off x="7036920" y="657360"/>
                <a:ext cx="41040" cy="31680"/>
              </a:xfrm>
              <a:prstGeom prst="rect">
                <a:avLst/>
              </a:prstGeom>
              <a:solidFill>
                <a:srgbClr val="ffffff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>
                <a:off x="7053120" y="669960"/>
                <a:ext cx="720" cy="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4" name=""/>
            <p:cNvGrpSpPr/>
            <p:nvPr/>
          </p:nvGrpSpPr>
          <p:grpSpPr>
            <a:xfrm>
              <a:off x="4631040" y="1186920"/>
              <a:ext cx="2890080" cy="1169280"/>
              <a:chOff x="4631040" y="1186920"/>
              <a:chExt cx="2890080" cy="1169280"/>
            </a:xfrm>
          </p:grpSpPr>
          <p:sp>
            <p:nvSpPr>
              <p:cNvPr id="295" name=""/>
              <p:cNvSpPr/>
              <p:nvPr/>
            </p:nvSpPr>
            <p:spPr>
              <a:xfrm>
                <a:off x="4631040" y="1186920"/>
                <a:ext cx="2890080" cy="1169280"/>
              </a:xfrm>
              <a:custGeom>
                <a:avLst/>
                <a:gdLst/>
                <a:ahLst/>
                <a:rect l="l" t="t" r="r" b="b"/>
                <a:pathLst>
                  <a:path w="2768" h="1448">
                    <a:moveTo>
                      <a:pt x="0" y="1448"/>
                    </a:moveTo>
                    <a:lnTo>
                      <a:pt x="2768" y="0"/>
                    </a:lnTo>
                    <a:lnTo>
                      <a:pt x="2768" y="0"/>
                    </a:lnTo>
                  </a:path>
                </a:pathLst>
              </a:custGeom>
              <a:noFill/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 flipV="1">
                <a:off x="4631040" y="1186920"/>
                <a:ext cx="2890080" cy="1169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7" name=""/>
            <p:cNvSpPr/>
            <p:nvPr/>
          </p:nvSpPr>
          <p:spPr>
            <a:xfrm>
              <a:off x="4939200" y="396360"/>
              <a:ext cx="21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663480"/>
                  <a:tab algn="l" pos="1327320"/>
                  <a:tab algn="l" pos="1990800"/>
                  <a:tab algn="l" pos="2654280"/>
                  <a:tab algn="l" pos="3317760"/>
                  <a:tab algn="l" pos="3981600"/>
                  <a:tab algn="l" pos="4645080"/>
                  <a:tab algn="l" pos="5308560"/>
                  <a:tab algn="l" pos="5972040"/>
                  <a:tab algn="l" pos="6635880"/>
                  <a:tab algn="l" pos="7299360"/>
                  <a:tab algn="l" pos="7962840"/>
                  <a:tab algn="l" pos="8626320"/>
                  <a:tab algn="l" pos="9290160"/>
                  <a:tab algn="l" pos="9953640"/>
                  <a:tab algn="l" pos="106171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y = 27.174 + 2.5376e-3x   R^2 = 0.26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5579640" y="0"/>
              <a:ext cx="1415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663480"/>
                  <a:tab algn="l" pos="1327320"/>
                  <a:tab algn="l" pos="1990800"/>
                  <a:tab algn="l" pos="2654280"/>
                  <a:tab algn="l" pos="3317760"/>
                  <a:tab algn="l" pos="3981600"/>
                  <a:tab algn="l" pos="4645080"/>
                  <a:tab algn="l" pos="5308560"/>
                  <a:tab algn="l" pos="5972040"/>
                  <a:tab algn="l" pos="6635880"/>
                  <a:tab algn="l" pos="7299360"/>
                  <a:tab algn="l" pos="7962840"/>
                  <a:tab algn="l" pos="8626320"/>
                  <a:tab algn="l" pos="9290160"/>
                  <a:tab algn="l" pos="9953640"/>
                  <a:tab algn="l" pos="106171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Palatino"/>
                </a:rPr>
                <a:t>b) Total Fat Oxidati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 rot="16200000">
              <a:off x="3364200" y="1803240"/>
              <a:ext cx="1474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663480"/>
                  <a:tab algn="l" pos="1327320"/>
                  <a:tab algn="l" pos="1990800"/>
                  <a:tab algn="l" pos="2654280"/>
                  <a:tab algn="l" pos="3317760"/>
                  <a:tab algn="l" pos="3981600"/>
                  <a:tab algn="l" pos="4645080"/>
                  <a:tab algn="l" pos="5308560"/>
                  <a:tab algn="l" pos="5972040"/>
                  <a:tab algn="l" pos="6635880"/>
                  <a:tab algn="l" pos="7299360"/>
                  <a:tab algn="l" pos="7962840"/>
                  <a:tab algn="l" pos="8626320"/>
                  <a:tab algn="l" pos="9290160"/>
                  <a:tab algn="l" pos="9953640"/>
                  <a:tab algn="l" pos="1061712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otal fat oxidation (g/6h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28T18:37:51Z</dcterms:created>
  <dc:creator>janine</dc:creator>
  <dc:description/>
  <dc:language>en-US</dc:language>
  <cp:lastModifiedBy>higbee</cp:lastModifiedBy>
  <dcterms:modified xsi:type="dcterms:W3CDTF">2004-10-02T00:24:35Z</dcterms:modified>
  <cp:revision>8</cp:revision>
  <dc:subject/>
  <dc:title>Slide 1</dc:title>
</cp:coreProperties>
</file>